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CF89B7-9D2F-4B27-BA2A-7808065D75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FF2331-ECCC-4681-9862-C0AF785EF9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5E7418-2120-4E86-80CF-0E3F77BBE3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CD84D-EAB8-496E-BED1-C8FF1AD029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23319-E4A0-43E3-8AB2-773DF3EAD4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740001-7FC9-4B60-BB23-77124BB707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47F3CB-0A38-4E44-B1CB-6A08551F0D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33DC7D-5602-4A9E-AFC7-1F31B20EEB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A81ADA-5A1D-4D13-A2DE-70B659E910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311CE-B36E-4FCF-AA5B-48347BB18C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1EB710-8A18-4018-B57C-288F8320F3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09998B-C3C1-4931-AD2D-77ED3CF15C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2B9D4D-5295-4C41-9238-B808C59A4B82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image" Target="../media/image1.jpeg"/><Relationship Id="rId4" Type="http://schemas.openxmlformats.org/officeDocument/2006/relationships/image" Target="../media/image1.jpeg"/><Relationship Id="rId5" Type="http://schemas.openxmlformats.org/officeDocument/2006/relationships/image" Target="../media/image2.jpeg"/><Relationship Id="rId6" Type="http://schemas.openxmlformats.org/officeDocument/2006/relationships/image" Target="../media/image2.jpeg"/><Relationship Id="rId7" Type="http://schemas.openxmlformats.org/officeDocument/2006/relationships/image" Target="../media/image2.jpeg"/><Relationship Id="rId8" Type="http://schemas.openxmlformats.org/officeDocument/2006/relationships/image" Target="../media/image3.jpeg"/><Relationship Id="rId9" Type="http://schemas.openxmlformats.org/officeDocument/2006/relationships/image" Target="../media/image3.jpeg"/><Relationship Id="rId10" Type="http://schemas.openxmlformats.org/officeDocument/2006/relationships/image" Target="../media/image3.jpeg"/><Relationship Id="rId11" Type="http://schemas.openxmlformats.org/officeDocument/2006/relationships/image" Target="../media/image3.jpeg"/><Relationship Id="rId12" Type="http://schemas.openxmlformats.org/officeDocument/2006/relationships/image" Target="../media/image4.jpeg"/><Relationship Id="rId13" Type="http://schemas.openxmlformats.org/officeDocument/2006/relationships/image" Target="../media/image4.jpeg"/><Relationship Id="rId14" Type="http://schemas.openxmlformats.org/officeDocument/2006/relationships/image" Target="../media/image4.jpeg"/><Relationship Id="rId15" Type="http://schemas.openxmlformats.org/officeDocument/2006/relationships/image" Target="../media/image4.jpeg"/><Relationship Id="rId1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73"/>
          <p:cNvGrpSpPr/>
          <p:nvPr/>
        </p:nvGrpSpPr>
        <p:grpSpPr>
          <a:xfrm>
            <a:off x="338040" y="1244520"/>
            <a:ext cx="6039000" cy="3427560"/>
            <a:chOff x="338040" y="1244520"/>
            <a:chExt cx="6039000" cy="3427560"/>
          </a:xfrm>
        </p:grpSpPr>
        <p:sp>
          <p:nvSpPr>
            <p:cNvPr id="42" name="TextBox 26"/>
            <p:cNvSpPr/>
            <p:nvPr/>
          </p:nvSpPr>
          <p:spPr>
            <a:xfrm>
              <a:off x="4183200" y="1722240"/>
              <a:ext cx="2182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RP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Box 52"/>
            <p:cNvSpPr/>
            <p:nvPr/>
          </p:nvSpPr>
          <p:spPr>
            <a:xfrm>
              <a:off x="356760" y="1528560"/>
              <a:ext cx="87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50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Box 53"/>
            <p:cNvSpPr/>
            <p:nvPr/>
          </p:nvSpPr>
          <p:spPr>
            <a:xfrm>
              <a:off x="358560" y="1815840"/>
              <a:ext cx="87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0 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Box 53"/>
            <p:cNvSpPr/>
            <p:nvPr/>
          </p:nvSpPr>
          <p:spPr>
            <a:xfrm>
              <a:off x="4860000" y="1722240"/>
              <a:ext cx="1057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uclea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32"/>
            <p:cNvSpPr/>
            <p:nvPr/>
          </p:nvSpPr>
          <p:spPr>
            <a:xfrm>
              <a:off x="2892240" y="1263240"/>
              <a:ext cx="934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</a:rPr>
                <a:t>De-glycosylate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Straight Connector 57"/>
            <p:cNvSpPr/>
            <p:nvPr/>
          </p:nvSpPr>
          <p:spPr>
            <a:xfrm flipV="1">
              <a:off x="1341360" y="1298160"/>
              <a:ext cx="0" cy="131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Straight Connector 59"/>
            <p:cNvSpPr/>
            <p:nvPr/>
          </p:nvSpPr>
          <p:spPr>
            <a:xfrm flipV="1">
              <a:off x="2700360" y="1303200"/>
              <a:ext cx="0" cy="13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Straight Connector 61"/>
            <p:cNvSpPr/>
            <p:nvPr/>
          </p:nvSpPr>
          <p:spPr>
            <a:xfrm>
              <a:off x="1346040" y="1363320"/>
              <a:ext cx="25236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Straight Connector 62"/>
            <p:cNvSpPr/>
            <p:nvPr/>
          </p:nvSpPr>
          <p:spPr>
            <a:xfrm flipV="1">
              <a:off x="2644560" y="1301400"/>
              <a:ext cx="0" cy="13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Straight Connector 63"/>
            <p:cNvSpPr/>
            <p:nvPr/>
          </p:nvSpPr>
          <p:spPr>
            <a:xfrm flipV="1">
              <a:off x="4000680" y="1292040"/>
              <a:ext cx="0" cy="13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Straight Connector 64"/>
            <p:cNvSpPr/>
            <p:nvPr/>
          </p:nvSpPr>
          <p:spPr>
            <a:xfrm>
              <a:off x="2386080" y="1365120"/>
              <a:ext cx="25056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Straight Connector 65"/>
            <p:cNvSpPr/>
            <p:nvPr/>
          </p:nvSpPr>
          <p:spPr>
            <a:xfrm>
              <a:off x="2703600" y="1369800"/>
              <a:ext cx="25236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Straight Connector 66"/>
            <p:cNvSpPr/>
            <p:nvPr/>
          </p:nvSpPr>
          <p:spPr>
            <a:xfrm>
              <a:off x="3753000" y="1360080"/>
              <a:ext cx="25236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32"/>
            <p:cNvSpPr/>
            <p:nvPr/>
          </p:nvSpPr>
          <p:spPr>
            <a:xfrm>
              <a:off x="1585800" y="1244520"/>
              <a:ext cx="934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</a:rPr>
                <a:t>Native protei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ight Brace 70"/>
            <p:cNvSpPr/>
            <p:nvPr/>
          </p:nvSpPr>
          <p:spPr>
            <a:xfrm>
              <a:off x="4067280" y="1483920"/>
              <a:ext cx="45720" cy="574560"/>
            </a:xfrm>
            <a:custGeom>
              <a:avLst/>
              <a:gdLst>
                <a:gd name="textAreaLeft" fmla="*/ 0 w 45720"/>
                <a:gd name="textAreaRight" fmla="*/ 16560 w 45720"/>
                <a:gd name="textAreaTop" fmla="*/ 1080 h 574560"/>
                <a:gd name="textAreaBottom" fmla="*/ 573480 h 574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72"/>
                    <a:pt x="10800" y="144"/>
                  </a:cubicBezTo>
                  <a:lnTo>
                    <a:pt x="10800" y="10656"/>
                  </a:lnTo>
                  <a:cubicBezTo>
                    <a:pt x="10800" y="10728"/>
                    <a:pt x="16200" y="10800"/>
                    <a:pt x="21600" y="10800"/>
                  </a:cubicBezTo>
                  <a:cubicBezTo>
                    <a:pt x="16200" y="10800"/>
                    <a:pt x="10800" y="10872"/>
                    <a:pt x="10800" y="10944"/>
                  </a:cubicBezTo>
                  <a:lnTo>
                    <a:pt x="10800" y="21456"/>
                  </a:lnTo>
                  <a:cubicBezTo>
                    <a:pt x="10800" y="21528"/>
                    <a:pt x="5400" y="21600"/>
                    <a:pt x="0" y="21600"/>
                  </a:cubicBezTo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7" name="Group 72"/>
            <p:cNvGrpSpPr/>
            <p:nvPr/>
          </p:nvGrpSpPr>
          <p:grpSpPr>
            <a:xfrm>
              <a:off x="1020600" y="1518840"/>
              <a:ext cx="2975040" cy="541080"/>
              <a:chOff x="1020600" y="1518840"/>
              <a:chExt cx="2975040" cy="541080"/>
            </a:xfrm>
          </p:grpSpPr>
          <p:pic>
            <p:nvPicPr>
              <p:cNvPr id="58" name="Picture 5" descr="P:\Lab4\Liz R\de phos de gly\020910 nuc shep a204 ht mcf a673 tc32 degly mrp1.jpg"/>
              <p:cNvPicPr/>
              <p:nvPr/>
            </p:nvPicPr>
            <p:blipFill>
              <a:blip r:embed="rId1"/>
              <a:srcRect l="7063" t="0" r="58224" b="74307"/>
              <a:stretch/>
            </p:blipFill>
            <p:spPr>
              <a:xfrm>
                <a:off x="1020600" y="1518840"/>
                <a:ext cx="1390680" cy="541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9" name="Picture 5" descr="P:\Lab4\Liz R\de phos de gly\020910 nuc shep a204 ht mcf a673 tc32 degly mrp1.jpg"/>
              <p:cNvPicPr/>
              <p:nvPr/>
            </p:nvPicPr>
            <p:blipFill>
              <a:blip r:embed="rId2"/>
              <a:srcRect l="87972" t="0" r="6158" b="74307"/>
              <a:stretch/>
            </p:blipFill>
            <p:spPr>
              <a:xfrm>
                <a:off x="3760560" y="1518840"/>
                <a:ext cx="235080" cy="541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0" name="Picture 5" descr="P:\Lab4\Liz R\de phos de gly\020910 nuc shep a204 ht mcf a673 tc32 degly mrp1.jpg"/>
              <p:cNvPicPr/>
              <p:nvPr/>
            </p:nvPicPr>
            <p:blipFill>
              <a:blip r:embed="rId3"/>
              <a:srcRect l="48206" t="0" r="44843" b="74307"/>
              <a:stretch/>
            </p:blipFill>
            <p:spPr>
              <a:xfrm>
                <a:off x="2420640" y="1518840"/>
                <a:ext cx="278640" cy="541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1" name="Picture 5" descr="P:\Lab4\Liz R\de phos de gly\020910 nuc shep a204 ht mcf a673 tc32 degly mrp1.jpg"/>
              <p:cNvPicPr/>
              <p:nvPr/>
            </p:nvPicPr>
            <p:blipFill>
              <a:blip r:embed="rId4"/>
              <a:srcRect l="55397" t="0" r="17641" b="74307"/>
              <a:stretch/>
            </p:blipFill>
            <p:spPr>
              <a:xfrm>
                <a:off x="2699280" y="1518840"/>
                <a:ext cx="1080360" cy="54108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62" name="Group 72"/>
            <p:cNvGrpSpPr/>
            <p:nvPr/>
          </p:nvGrpSpPr>
          <p:grpSpPr>
            <a:xfrm>
              <a:off x="356760" y="2205000"/>
              <a:ext cx="5997240" cy="595080"/>
              <a:chOff x="356760" y="2205000"/>
              <a:chExt cx="5997240" cy="595080"/>
            </a:xfrm>
          </p:grpSpPr>
          <p:grpSp>
            <p:nvGrpSpPr>
              <p:cNvPr id="63" name="Group 73"/>
              <p:cNvGrpSpPr/>
              <p:nvPr/>
            </p:nvGrpSpPr>
            <p:grpSpPr>
              <a:xfrm>
                <a:off x="356760" y="2205000"/>
                <a:ext cx="5997240" cy="533520"/>
                <a:chOff x="356760" y="2205000"/>
                <a:chExt cx="5997240" cy="533520"/>
              </a:xfrm>
            </p:grpSpPr>
            <p:grpSp>
              <p:nvGrpSpPr>
                <p:cNvPr id="64" name="Group 61"/>
                <p:cNvGrpSpPr/>
                <p:nvPr/>
              </p:nvGrpSpPr>
              <p:grpSpPr>
                <a:xfrm>
                  <a:off x="356760" y="2205000"/>
                  <a:ext cx="5997240" cy="533520"/>
                  <a:chOff x="356760" y="2205000"/>
                  <a:chExt cx="5997240" cy="533520"/>
                </a:xfrm>
              </p:grpSpPr>
              <p:sp>
                <p:nvSpPr>
                  <p:cNvPr id="65" name="TextBox 26"/>
                  <p:cNvSpPr/>
                  <p:nvPr/>
                </p:nvSpPr>
                <p:spPr>
                  <a:xfrm>
                    <a:off x="4192560" y="2390400"/>
                    <a:ext cx="216144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MRP-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" name="TextBox 52"/>
                  <p:cNvSpPr/>
                  <p:nvPr/>
                </p:nvSpPr>
                <p:spPr>
                  <a:xfrm>
                    <a:off x="356760" y="2205000"/>
                    <a:ext cx="86508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250 kDa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" name="TextBox 53"/>
                  <p:cNvSpPr/>
                  <p:nvPr/>
                </p:nvSpPr>
                <p:spPr>
                  <a:xfrm>
                    <a:off x="358560" y="2492280"/>
                    <a:ext cx="86508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50 kDa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68" name="TextBox 53"/>
                <p:cNvSpPr/>
                <p:nvPr/>
              </p:nvSpPr>
              <p:spPr>
                <a:xfrm>
                  <a:off x="4860000" y="2390400"/>
                  <a:ext cx="14623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Plasma membrane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9" name="Right Brace 69"/>
              <p:cNvSpPr/>
              <p:nvPr/>
            </p:nvSpPr>
            <p:spPr>
              <a:xfrm>
                <a:off x="4066920" y="2225520"/>
                <a:ext cx="45720" cy="574560"/>
              </a:xfrm>
              <a:custGeom>
                <a:avLst/>
                <a:gdLst>
                  <a:gd name="textAreaLeft" fmla="*/ 0 w 45720"/>
                  <a:gd name="textAreaRight" fmla="*/ 16560 w 45720"/>
                  <a:gd name="textAreaTop" fmla="*/ 1080 h 574560"/>
                  <a:gd name="textAreaBottom" fmla="*/ 573480 h 5745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72"/>
                      <a:pt x="10800" y="144"/>
                    </a:cubicBezTo>
                    <a:lnTo>
                      <a:pt x="10800" y="10656"/>
                    </a:lnTo>
                    <a:cubicBezTo>
                      <a:pt x="10800" y="10728"/>
                      <a:pt x="16200" y="10800"/>
                      <a:pt x="21600" y="10800"/>
                    </a:cubicBezTo>
                    <a:cubicBezTo>
                      <a:pt x="16200" y="10800"/>
                      <a:pt x="10800" y="10872"/>
                      <a:pt x="10800" y="10944"/>
                    </a:cubicBezTo>
                    <a:lnTo>
                      <a:pt x="10800" y="21456"/>
                    </a:lnTo>
                    <a:cubicBezTo>
                      <a:pt x="10800" y="21528"/>
                      <a:pt x="5400" y="21600"/>
                      <a:pt x="0" y="21600"/>
                    </a:cubicBezTo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0" name="Group 76"/>
              <p:cNvGrpSpPr/>
              <p:nvPr/>
            </p:nvGrpSpPr>
            <p:grpSpPr>
              <a:xfrm>
                <a:off x="1018800" y="2209680"/>
                <a:ext cx="2976840" cy="590400"/>
                <a:chOff x="1018800" y="2209680"/>
                <a:chExt cx="2976840" cy="590400"/>
              </a:xfrm>
            </p:grpSpPr>
            <p:pic>
              <p:nvPicPr>
                <p:cNvPr id="71" name="Picture 3" descr="P:\Lab4\Liz R\de phos de gly\020910 mem shep a204 ht mcf a673 tc32 degly mrp1.jpg"/>
                <p:cNvPicPr/>
                <p:nvPr/>
              </p:nvPicPr>
              <p:blipFill>
                <a:blip r:embed="rId5">
                  <a:lum bright="10000"/>
                </a:blip>
                <a:srcRect l="51938" t="9927" r="16111" b="66466"/>
                <a:stretch/>
              </p:blipFill>
              <p:spPr>
                <a:xfrm>
                  <a:off x="2688840" y="2209680"/>
                  <a:ext cx="1306800" cy="5904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2" name="Picture 3" descr="P:\Lab4\Liz R\de phos de gly\020910 mem shep a204 ht mcf a673 tc32 degly mrp1.jpg"/>
                <p:cNvPicPr/>
                <p:nvPr/>
              </p:nvPicPr>
              <p:blipFill>
                <a:blip r:embed="rId6">
                  <a:lum bright="10000"/>
                </a:blip>
                <a:srcRect l="3996" t="9927" r="62276" b="66466"/>
                <a:stretch/>
              </p:blipFill>
              <p:spPr>
                <a:xfrm>
                  <a:off x="1018800" y="2209680"/>
                  <a:ext cx="1379520" cy="5904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3" name="Picture 3" descr="P:\Lab4\Liz R\de phos de gly\020910 mem shep a204 ht mcf a673 tc32 degly mrp1.jpg"/>
                <p:cNvPicPr/>
                <p:nvPr/>
              </p:nvPicPr>
              <p:blipFill>
                <a:blip r:embed="rId7">
                  <a:lum bright="10000"/>
                </a:blip>
                <a:srcRect l="44747" t="9927" r="47894" b="66466"/>
                <a:stretch/>
              </p:blipFill>
              <p:spPr>
                <a:xfrm>
                  <a:off x="2398320" y="2209680"/>
                  <a:ext cx="300960" cy="5904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</p:grpSp>
        <p:grpSp>
          <p:nvGrpSpPr>
            <p:cNvPr id="74" name="Group 73"/>
            <p:cNvGrpSpPr/>
            <p:nvPr/>
          </p:nvGrpSpPr>
          <p:grpSpPr>
            <a:xfrm>
              <a:off x="352080" y="2924280"/>
              <a:ext cx="6024960" cy="592200"/>
              <a:chOff x="352080" y="2924280"/>
              <a:chExt cx="6024960" cy="592200"/>
            </a:xfrm>
          </p:grpSpPr>
          <p:grpSp>
            <p:nvGrpSpPr>
              <p:cNvPr id="75" name="Group 72"/>
              <p:cNvGrpSpPr/>
              <p:nvPr/>
            </p:nvGrpSpPr>
            <p:grpSpPr>
              <a:xfrm>
                <a:off x="352080" y="2924280"/>
                <a:ext cx="6024960" cy="534240"/>
                <a:chOff x="352080" y="2924280"/>
                <a:chExt cx="6024960" cy="534240"/>
              </a:xfrm>
            </p:grpSpPr>
            <p:grpSp>
              <p:nvGrpSpPr>
                <p:cNvPr id="76" name="Group 60"/>
                <p:cNvGrpSpPr/>
                <p:nvPr/>
              </p:nvGrpSpPr>
              <p:grpSpPr>
                <a:xfrm>
                  <a:off x="352080" y="2924280"/>
                  <a:ext cx="6024960" cy="534240"/>
                  <a:chOff x="352080" y="2924280"/>
                  <a:chExt cx="6024960" cy="534240"/>
                </a:xfrm>
              </p:grpSpPr>
              <p:sp>
                <p:nvSpPr>
                  <p:cNvPr id="77" name="TextBox 26"/>
                  <p:cNvSpPr/>
                  <p:nvPr/>
                </p:nvSpPr>
                <p:spPr>
                  <a:xfrm>
                    <a:off x="4192920" y="3134880"/>
                    <a:ext cx="218412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MRP-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" name="TextBox 52"/>
                  <p:cNvSpPr/>
                  <p:nvPr/>
                </p:nvSpPr>
                <p:spPr>
                  <a:xfrm>
                    <a:off x="352080" y="2924280"/>
                    <a:ext cx="87444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250 kDa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" name="TextBox 53"/>
                  <p:cNvSpPr/>
                  <p:nvPr/>
                </p:nvSpPr>
                <p:spPr>
                  <a:xfrm>
                    <a:off x="353880" y="3212280"/>
                    <a:ext cx="87444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50 kDa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80" name="TextBox 53"/>
                <p:cNvSpPr/>
                <p:nvPr/>
              </p:nvSpPr>
              <p:spPr>
                <a:xfrm>
                  <a:off x="4860000" y="3134880"/>
                  <a:ext cx="606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Total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1" name="Right Brace 68"/>
              <p:cNvSpPr/>
              <p:nvPr/>
            </p:nvSpPr>
            <p:spPr>
              <a:xfrm>
                <a:off x="4067280" y="2938320"/>
                <a:ext cx="45720" cy="578160"/>
              </a:xfrm>
              <a:custGeom>
                <a:avLst/>
                <a:gdLst>
                  <a:gd name="textAreaLeft" fmla="*/ 0 w 45720"/>
                  <a:gd name="textAreaRight" fmla="*/ 16560 w 45720"/>
                  <a:gd name="textAreaTop" fmla="*/ 1080 h 578160"/>
                  <a:gd name="textAreaBottom" fmla="*/ 577080 h 5781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72"/>
                      <a:pt x="10800" y="144"/>
                    </a:cubicBezTo>
                    <a:lnTo>
                      <a:pt x="10800" y="10656"/>
                    </a:lnTo>
                    <a:cubicBezTo>
                      <a:pt x="10800" y="10728"/>
                      <a:pt x="16200" y="10800"/>
                      <a:pt x="21600" y="10800"/>
                    </a:cubicBezTo>
                    <a:cubicBezTo>
                      <a:pt x="16200" y="10800"/>
                      <a:pt x="10800" y="10872"/>
                      <a:pt x="10800" y="10944"/>
                    </a:cubicBezTo>
                    <a:lnTo>
                      <a:pt x="10800" y="21456"/>
                    </a:lnTo>
                    <a:cubicBezTo>
                      <a:pt x="10800" y="21528"/>
                      <a:pt x="5400" y="21600"/>
                      <a:pt x="0" y="21600"/>
                    </a:cubicBezTo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2" name="Group 81"/>
              <p:cNvGrpSpPr/>
              <p:nvPr/>
            </p:nvGrpSpPr>
            <p:grpSpPr>
              <a:xfrm>
                <a:off x="1037880" y="2975040"/>
                <a:ext cx="2957760" cy="469080"/>
                <a:chOff x="1037880" y="2975040"/>
                <a:chExt cx="2957760" cy="469080"/>
              </a:xfrm>
            </p:grpSpPr>
            <p:pic>
              <p:nvPicPr>
                <p:cNvPr id="83" name="Picture 5" descr="E:\liz r\080910 total shep a204 ht mcf a673 tc32 degly mrp1.jpg"/>
                <p:cNvPicPr/>
                <p:nvPr/>
              </p:nvPicPr>
              <p:blipFill>
                <a:blip r:embed="rId8"/>
                <a:srcRect l="3082" t="2371" r="67421" b="78380"/>
                <a:stretch/>
              </p:blipFill>
              <p:spPr>
                <a:xfrm>
                  <a:off x="1037880" y="2975040"/>
                  <a:ext cx="1368360" cy="4690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4" name="Picture 5" descr="E:\liz r\080910 total shep a204 ht mcf a673 tc32 degly mrp1.jpg"/>
                <p:cNvPicPr/>
                <p:nvPr/>
              </p:nvPicPr>
              <p:blipFill>
                <a:blip r:embed="rId9"/>
                <a:srcRect l="72952" t="2371" r="20528" b="78380"/>
                <a:stretch/>
              </p:blipFill>
              <p:spPr>
                <a:xfrm>
                  <a:off x="3693240" y="2975040"/>
                  <a:ext cx="302400" cy="4690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5" name="Picture 5" descr="E:\liz r\080910 total shep a204 ht mcf a673 tc32 degly mrp1.jpg"/>
                <p:cNvPicPr/>
                <p:nvPr/>
              </p:nvPicPr>
              <p:blipFill>
                <a:blip r:embed="rId10"/>
                <a:srcRect l="38793" t="2371" r="56445" b="78380"/>
                <a:stretch/>
              </p:blipFill>
              <p:spPr>
                <a:xfrm>
                  <a:off x="2406240" y="2975040"/>
                  <a:ext cx="221040" cy="4690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6" name="Picture 5" descr="E:\liz r\080910 total shep a204 ht mcf a673 tc32 degly mrp1.jpg"/>
                <p:cNvPicPr/>
                <p:nvPr/>
              </p:nvPicPr>
              <p:blipFill>
                <a:blip r:embed="rId11"/>
                <a:srcRect l="43455" t="2371" r="33262" b="78380"/>
                <a:stretch/>
              </p:blipFill>
              <p:spPr>
                <a:xfrm>
                  <a:off x="2612880" y="2975040"/>
                  <a:ext cx="1080360" cy="46908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</p:grpSp>
        <p:grpSp>
          <p:nvGrpSpPr>
            <p:cNvPr id="87" name="Group 74"/>
            <p:cNvGrpSpPr/>
            <p:nvPr/>
          </p:nvGrpSpPr>
          <p:grpSpPr>
            <a:xfrm>
              <a:off x="338040" y="3571920"/>
              <a:ext cx="6038640" cy="1100160"/>
              <a:chOff x="338040" y="3571920"/>
              <a:chExt cx="6038640" cy="1100160"/>
            </a:xfrm>
          </p:grpSpPr>
          <p:grpSp>
            <p:nvGrpSpPr>
              <p:cNvPr id="88" name="Group 82"/>
              <p:cNvGrpSpPr/>
              <p:nvPr/>
            </p:nvGrpSpPr>
            <p:grpSpPr>
              <a:xfrm>
                <a:off x="338040" y="3573360"/>
                <a:ext cx="6038640" cy="604440"/>
                <a:chOff x="338040" y="3573360"/>
                <a:chExt cx="6038640" cy="604440"/>
              </a:xfrm>
            </p:grpSpPr>
            <p:grpSp>
              <p:nvGrpSpPr>
                <p:cNvPr id="89" name="Group 63"/>
                <p:cNvGrpSpPr/>
                <p:nvPr/>
              </p:nvGrpSpPr>
              <p:grpSpPr>
                <a:xfrm>
                  <a:off x="338040" y="3573360"/>
                  <a:ext cx="6038640" cy="604440"/>
                  <a:chOff x="338040" y="3573360"/>
                  <a:chExt cx="6038640" cy="604440"/>
                </a:xfrm>
              </p:grpSpPr>
              <p:sp>
                <p:nvSpPr>
                  <p:cNvPr id="90" name="TextBox 26"/>
                  <p:cNvSpPr/>
                  <p:nvPr/>
                </p:nvSpPr>
                <p:spPr>
                  <a:xfrm>
                    <a:off x="4192920" y="3816360"/>
                    <a:ext cx="21837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MRP-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91" name="Group 59"/>
                  <p:cNvGrpSpPr/>
                  <p:nvPr/>
                </p:nvGrpSpPr>
                <p:grpSpPr>
                  <a:xfrm>
                    <a:off x="338040" y="3573360"/>
                    <a:ext cx="3784680" cy="604440"/>
                    <a:chOff x="338040" y="3573360"/>
                    <a:chExt cx="3784680" cy="604440"/>
                  </a:xfrm>
                </p:grpSpPr>
                <p:sp>
                  <p:nvSpPr>
                    <p:cNvPr id="92" name="TextBox 52"/>
                    <p:cNvSpPr/>
                    <p:nvPr/>
                  </p:nvSpPr>
                  <p:spPr>
                    <a:xfrm>
                      <a:off x="338040" y="3573360"/>
                      <a:ext cx="87408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0 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" name="TextBox 53"/>
                    <p:cNvSpPr/>
                    <p:nvPr/>
                  </p:nvSpPr>
                  <p:spPr>
                    <a:xfrm>
                      <a:off x="339840" y="3859920"/>
                      <a:ext cx="87408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0 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" name="Right Brace 58"/>
                    <p:cNvSpPr/>
                    <p:nvPr/>
                  </p:nvSpPr>
                  <p:spPr>
                    <a:xfrm>
                      <a:off x="4077000" y="3601800"/>
                      <a:ext cx="45720" cy="576000"/>
                    </a:xfrm>
                    <a:custGeom>
                      <a:avLst/>
                      <a:gdLst>
                        <a:gd name="textAreaLeft" fmla="*/ 0 w 45720"/>
                        <a:gd name="textAreaRight" fmla="*/ 16560 w 45720"/>
                        <a:gd name="textAreaTop" fmla="*/ 720 h 576000"/>
                        <a:gd name="textAreaBottom" fmla="*/ 575280 h 576000"/>
                      </a:gdLst>
                      <a:ahLst/>
                      <a:rect l="textAreaLeft" t="textAreaTop" r="textAreaRight" b="textAreaBottom"/>
                      <a:pathLst>
                        <a:path w="21600" h="21600">
                          <a:moveTo>
                            <a:pt x="0" y="0"/>
                          </a:moveTo>
                          <a:cubicBezTo>
                            <a:pt x="5400" y="0"/>
                            <a:pt x="10800" y="59"/>
                            <a:pt x="10800" y="117"/>
                          </a:cubicBezTo>
                          <a:lnTo>
                            <a:pt x="10800" y="10683"/>
                          </a:lnTo>
                          <a:cubicBezTo>
                            <a:pt x="10800" y="10742"/>
                            <a:pt x="16200" y="10800"/>
                            <a:pt x="21600" y="10800"/>
                          </a:cubicBezTo>
                          <a:cubicBezTo>
                            <a:pt x="16200" y="10800"/>
                            <a:pt x="10800" y="10859"/>
                            <a:pt x="10800" y="10917"/>
                          </a:cubicBezTo>
                          <a:lnTo>
                            <a:pt x="10800" y="21483"/>
                          </a:lnTo>
                          <a:cubicBezTo>
                            <a:pt x="10800" y="21542"/>
                            <a:pt x="5400" y="21600"/>
                            <a:pt x="0" y="21600"/>
                          </a:cubicBezTo>
                        </a:path>
                      </a:pathLst>
                    </a:custGeom>
                    <a:solidFill>
                      <a:srgbClr val="ffffff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sp>
              <p:nvSpPr>
                <p:cNvPr id="95" name="TextBox 53"/>
                <p:cNvSpPr/>
                <p:nvPr/>
              </p:nvSpPr>
              <p:spPr>
                <a:xfrm>
                  <a:off x="4860360" y="3816360"/>
                  <a:ext cx="11455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Mitochondria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6" name="Group 55"/>
              <p:cNvGrpSpPr/>
              <p:nvPr/>
            </p:nvGrpSpPr>
            <p:grpSpPr>
              <a:xfrm>
                <a:off x="1000080" y="4049280"/>
                <a:ext cx="2968920" cy="622800"/>
                <a:chOff x="1000080" y="4049280"/>
                <a:chExt cx="2968920" cy="622800"/>
              </a:xfrm>
            </p:grpSpPr>
            <p:sp>
              <p:nvSpPr>
                <p:cNvPr id="97" name="TextBox 12"/>
                <p:cNvSpPr/>
                <p:nvPr/>
              </p:nvSpPr>
              <p:spPr>
                <a:xfrm rot="16200000">
                  <a:off x="837000" y="4260960"/>
                  <a:ext cx="5720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MW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TextBox 18"/>
                <p:cNvSpPr/>
                <p:nvPr/>
              </p:nvSpPr>
              <p:spPr>
                <a:xfrm rot="16200000">
                  <a:off x="1901520" y="4260240"/>
                  <a:ext cx="57456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MCF-7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TextBox 19"/>
                <p:cNvSpPr/>
                <p:nvPr/>
              </p:nvSpPr>
              <p:spPr>
                <a:xfrm rot="16200000">
                  <a:off x="1667880" y="4260240"/>
                  <a:ext cx="57456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HT-29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TextBox 20"/>
                <p:cNvSpPr/>
                <p:nvPr/>
              </p:nvSpPr>
              <p:spPr>
                <a:xfrm rot="16200000">
                  <a:off x="1406880" y="4260240"/>
                  <a:ext cx="57456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204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TextBox 25"/>
                <p:cNvSpPr/>
                <p:nvPr/>
              </p:nvSpPr>
              <p:spPr>
                <a:xfrm rot="16200000">
                  <a:off x="1122480" y="4244400"/>
                  <a:ext cx="60552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HEP-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TextBox 21"/>
                <p:cNvSpPr/>
                <p:nvPr/>
              </p:nvSpPr>
              <p:spPr>
                <a:xfrm rot="16200000">
                  <a:off x="2166840" y="4236840"/>
                  <a:ext cx="6213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TC-3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TextBox 18"/>
                <p:cNvSpPr/>
                <p:nvPr/>
              </p:nvSpPr>
              <p:spPr>
                <a:xfrm rot="16200000">
                  <a:off x="3281400" y="4261680"/>
                  <a:ext cx="57456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MCF-7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TextBox 19"/>
                <p:cNvSpPr/>
                <p:nvPr/>
              </p:nvSpPr>
              <p:spPr>
                <a:xfrm rot="16200000">
                  <a:off x="3009240" y="4261680"/>
                  <a:ext cx="57456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HT-29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TextBox 20"/>
                <p:cNvSpPr/>
                <p:nvPr/>
              </p:nvSpPr>
              <p:spPr>
                <a:xfrm rot="16200000">
                  <a:off x="2719440" y="4261680"/>
                  <a:ext cx="57456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204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TextBox 25"/>
                <p:cNvSpPr/>
                <p:nvPr/>
              </p:nvSpPr>
              <p:spPr>
                <a:xfrm rot="16200000">
                  <a:off x="2435040" y="4246200"/>
                  <a:ext cx="60552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HEP-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TextBox 21"/>
                <p:cNvSpPr/>
                <p:nvPr/>
              </p:nvSpPr>
              <p:spPr>
                <a:xfrm rot="16200000">
                  <a:off x="3535200" y="4238280"/>
                  <a:ext cx="6213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TC-3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8" name="Group 86"/>
              <p:cNvGrpSpPr/>
              <p:nvPr/>
            </p:nvGrpSpPr>
            <p:grpSpPr>
              <a:xfrm>
                <a:off x="985680" y="3571920"/>
                <a:ext cx="3082320" cy="567360"/>
                <a:chOff x="985680" y="3571920"/>
                <a:chExt cx="3082320" cy="567360"/>
              </a:xfrm>
            </p:grpSpPr>
            <p:pic>
              <p:nvPicPr>
                <p:cNvPr id="109" name="Picture 4" descr="E:\liz r\080910 mito shep a204 ht mcf a673 tc32 degly mrp1.jpg"/>
                <p:cNvPicPr/>
                <p:nvPr/>
              </p:nvPicPr>
              <p:blipFill>
                <a:blip r:embed="rId12"/>
                <a:srcRect l="8001" t="-853" r="61727" b="80154"/>
                <a:stretch/>
              </p:blipFill>
              <p:spPr>
                <a:xfrm>
                  <a:off x="985680" y="3571920"/>
                  <a:ext cx="1415880" cy="5673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10" name="Picture 4" descr="E:\liz r\080910 mito shep a204 ht mcf a673 tc32 degly mrp1.jpg"/>
                <p:cNvPicPr/>
                <p:nvPr/>
              </p:nvPicPr>
              <p:blipFill>
                <a:blip r:embed="rId13"/>
                <a:srcRect l="43064" t="-853" r="50516" b="80154"/>
                <a:stretch/>
              </p:blipFill>
              <p:spPr>
                <a:xfrm>
                  <a:off x="2327040" y="3571920"/>
                  <a:ext cx="300600" cy="5673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11" name="Picture 4" descr="E:\liz r\080910 mito shep a204 ht mcf a673 tc32 degly mrp1.jpg"/>
                <p:cNvPicPr/>
                <p:nvPr/>
              </p:nvPicPr>
              <p:blipFill>
                <a:blip r:embed="rId14"/>
                <a:srcRect l="49434" t="-853" r="26671" b="80154"/>
                <a:stretch/>
              </p:blipFill>
              <p:spPr>
                <a:xfrm>
                  <a:off x="2615400" y="3571920"/>
                  <a:ext cx="1117800" cy="5673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12" name="Picture 4" descr="E:\liz r\080910 mito shep a204 ht mcf a673 tc32 degly mrp1.jpg"/>
                <p:cNvPicPr/>
                <p:nvPr/>
              </p:nvPicPr>
              <p:blipFill>
                <a:blip r:embed="rId15"/>
                <a:srcRect l="78119" t="-853" r="13987" b="80154"/>
                <a:stretch/>
              </p:blipFill>
              <p:spPr>
                <a:xfrm>
                  <a:off x="3698640" y="3571920"/>
                  <a:ext cx="369360" cy="5673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4T11:01:51Z</dcterms:created>
  <dc:creator>medear</dc:creator>
  <dc:description/>
  <dc:language>en-US</dc:language>
  <cp:lastModifiedBy>medear</cp:lastModifiedBy>
  <dcterms:modified xsi:type="dcterms:W3CDTF">2011-09-01T14:56:48Z</dcterms:modified>
  <cp:revision>49</cp:revision>
  <dc:subject/>
  <dc:title>Slide 1</dc:title>
</cp:coreProperties>
</file>